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256816" y="71415"/>
            <a:ext cx="3172836" cy="3143271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5" name="Picture 4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71538" y="428604"/>
            <a:ext cx="2643206" cy="2643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071538" y="3571876"/>
            <a:ext cx="2643207" cy="24314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1" y="3429000"/>
            <a:ext cx="3180871" cy="257176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6: </a:t>
            </a:r>
            <a:r>
              <a:rPr lang="en-GB" sz="1600" dirty="0" smtClean="0"/>
              <a:t>3D model structure and validation of ABCB1 gene. A) Wild (Template </a:t>
            </a:r>
            <a:r>
              <a:rPr lang="en-US" sz="1600" dirty="0" smtClean="0"/>
              <a:t>5ko2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5ko2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0</cp:revision>
  <dcterms:created xsi:type="dcterms:W3CDTF">2018-05-10T07:33:24Z</dcterms:created>
  <dcterms:modified xsi:type="dcterms:W3CDTF">2018-05-29T06:49:38Z</dcterms:modified>
</cp:coreProperties>
</file>